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1" d="100"/>
          <a:sy n="91" d="100"/>
        </p:scale>
        <p:origin x="-1304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4C7EB-2657-4169-97F1-BC360943C9C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E503-500F-491D-908C-DCD00929C0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4C7EB-2657-4169-97F1-BC360943C9C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E503-500F-491D-908C-DCD00929C0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4C7EB-2657-4169-97F1-BC360943C9C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E503-500F-491D-908C-DCD00929C0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4C7EB-2657-4169-97F1-BC360943C9C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E503-500F-491D-908C-DCD00929C0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4C7EB-2657-4169-97F1-BC360943C9C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E503-500F-491D-908C-DCD00929C0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4C7EB-2657-4169-97F1-BC360943C9C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E503-500F-491D-908C-DCD00929C0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4C7EB-2657-4169-97F1-BC360943C9C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E503-500F-491D-908C-DCD00929C0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4C7EB-2657-4169-97F1-BC360943C9C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E503-500F-491D-908C-DCD00929C0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4C7EB-2657-4169-97F1-BC360943C9C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E503-500F-491D-908C-DCD00929C0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4C7EB-2657-4169-97F1-BC360943C9C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E503-500F-491D-908C-DCD00929C0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4C7EB-2657-4169-97F1-BC360943C9C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E503-500F-491D-908C-DCD00929C0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4C7EB-2657-4169-97F1-BC360943C9C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8AE503-500F-491D-908C-DCD00929C0B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igS2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160" y="0"/>
            <a:ext cx="6583680" cy="9144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310234" y="6781800"/>
            <a:ext cx="3547766" cy="1600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4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igure S2: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Cytokine levels in plasma of the </a:t>
            </a:r>
          </a:p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BALB/c mice with tumor. G-CSF level was </a:t>
            </a:r>
          </a:p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ignificantly decreased by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oxycycline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ox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). </a:t>
            </a:r>
          </a:p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n=6 for each group. Results are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means±SEM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.</a:t>
            </a:r>
          </a:p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**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&lt;0.01 relative to control. Results were</a:t>
            </a:r>
          </a:p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nalyzed </a:t>
            </a:r>
            <a:r>
              <a:rPr lang="en-US" sz="1400" smtClean="0">
                <a:latin typeface="Times New Roman" pitchFamily="18" charset="0"/>
                <a:cs typeface="Times New Roman" pitchFamily="18" charset="0"/>
              </a:rPr>
              <a:t>by </a:t>
            </a:r>
            <a:r>
              <a:rPr lang="en-US" sz="1400" smtClean="0">
                <a:latin typeface="Times New Roman" pitchFamily="18" charset="0"/>
                <a:cs typeface="Times New Roman" pitchFamily="18" charset="0"/>
              </a:rPr>
              <a:t>Student’s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-test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0</Words>
  <Application>Microsoft Macintosh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iaoyun</dc:creator>
  <cp:lastModifiedBy>David Brindley</cp:lastModifiedBy>
  <cp:revision>3</cp:revision>
  <dcterms:created xsi:type="dcterms:W3CDTF">2016-12-20T00:04:56Z</dcterms:created>
  <dcterms:modified xsi:type="dcterms:W3CDTF">2017-01-04T23:31:46Z</dcterms:modified>
</cp:coreProperties>
</file>